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colors3.xml" ContentType="application/vnd.ms-office.chartcolorstyle+xml"/>
  <Override PartName="/ppt/charts/colors4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charts/style3.xml" ContentType="application/vnd.ms-office.chartstyle+xml"/>
  <Override PartName="/ppt/charts/style4.xml" ContentType="application/vnd.ms-office.chartstyl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256" r:id="rId3"/>
    <p:sldId id="258" r:id="rId4"/>
    <p:sldId id="259" r:id="rId5"/>
    <p:sldId id="257" r:id="rId6"/>
    <p:sldId id="260" r:id="rId7"/>
    <p:sldId id="261" r:id="rId8"/>
    <p:sldId id="262" r:id="rId9"/>
    <p:sldId id="303" r:id="rId10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3" autoAdjust="0"/>
    <p:restoredTop sz="94660"/>
  </p:normalViewPr>
  <p:slideViewPr>
    <p:cSldViewPr snapToGrid="0">
      <p:cViewPr>
        <p:scale>
          <a:sx n="50" d="100"/>
          <a:sy n="50" d="100"/>
        </p:scale>
        <p:origin x="1843" y="6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E:\paper\black%20ginger\Melanoma_MeOH,%20DCM,%20EtOAc\WST-1\melanoma%20cell\A2058\DMSO%200.05%25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E:\paper\black%20ginger\Melanoma_MeOH,%20DCM,%20EtOAc\WST-1\melanoma%20cell\A375\_DMSO%200.05%25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E:\paper\black%20ginger\Melanoma_MeOH,%20DCM,%20EtOAc\WST-1\melanoma%20cell\A2058\DMSO%200.05%25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E:\paper\black%20ginger\Melanoma_MeOH,%20DCM,%20EtOAc\WST-1\melanoma%20cell\A375\_DMSO%200.05%2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3"/>
          <c:order val="0"/>
          <c:tx>
            <c:strRef>
              <c:f>'merge_220109_48h(1,2)'!$G$1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9_48h(1,2)'!$N$13</c:f>
                <c:numCache>
                  <c:formatCode>General</c:formatCode>
                  <c:ptCount val="1"/>
                  <c:pt idx="0">
                    <c:v>1.74184661641261</c:v>
                  </c:pt>
                </c:numCache>
              </c:numRef>
            </c:plus>
            <c:minus>
              <c:numRef>
                <c:f>'merge_220109_48h(1,2)'!$N$13</c:f>
                <c:numCache>
                  <c:formatCode>General</c:formatCode>
                  <c:ptCount val="1"/>
                  <c:pt idx="0">
                    <c:v>1.7418466164126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[1]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merge_220109_48h(1,2)'!$G$13</c:f>
              <c:numCache>
                <c:formatCode>0.00</c:formatCode>
                <c:ptCount val="1"/>
                <c:pt idx="0">
                  <c:v>99.9497276916632</c:v>
                </c:pt>
              </c:numCache>
            </c:numRef>
          </c:val>
        </c:ser>
        <c:ser>
          <c:idx val="4"/>
          <c:order val="1"/>
          <c:tx>
            <c:strRef>
              <c:f>'merge_220109_48h(1,2)'!$F$20</c:f>
              <c:strCache>
                <c:ptCount val="1"/>
                <c:pt idx="0">
                  <c:v>KPE-Hexane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9_48h(1,2)'!$M$13:$M$17</c:f>
                <c:numCache>
                  <c:formatCode>General</c:formatCode>
                  <c:ptCount val="5"/>
                  <c:pt idx="0">
                    <c:v>3.7117921944983</c:v>
                  </c:pt>
                  <c:pt idx="1">
                    <c:v>8.67664751610976</c:v>
                  </c:pt>
                  <c:pt idx="2">
                    <c:v>1.65890153944058</c:v>
                  </c:pt>
                  <c:pt idx="3">
                    <c:v>2.48835230916088</c:v>
                  </c:pt>
                  <c:pt idx="4">
                    <c:v>1.47227511625351</c:v>
                  </c:pt>
                </c:numCache>
              </c:numRef>
            </c:plus>
            <c:minus>
              <c:numRef>
                <c:f>'merge_220109_48h(1,2)'!$M$13:$M$17</c:f>
                <c:numCache>
                  <c:formatCode>General</c:formatCode>
                  <c:ptCount val="5"/>
                  <c:pt idx="0">
                    <c:v>3.7117921944983</c:v>
                  </c:pt>
                  <c:pt idx="1">
                    <c:v>8.67664751610976</c:v>
                  </c:pt>
                  <c:pt idx="2">
                    <c:v>1.65890153944058</c:v>
                  </c:pt>
                  <c:pt idx="3">
                    <c:v>2.48835230916088</c:v>
                  </c:pt>
                  <c:pt idx="4">
                    <c:v>1.4722751162535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'merge_220109_48h(1,2)'!$F$13:$F$17</c:f>
              <c:numCache>
                <c:formatCode>0.00</c:formatCode>
                <c:ptCount val="5"/>
                <c:pt idx="0">
                  <c:v>71.9836614997905</c:v>
                </c:pt>
                <c:pt idx="1">
                  <c:v>61.4599916212819</c:v>
                </c:pt>
                <c:pt idx="2">
                  <c:v>62.2203602848764</c:v>
                </c:pt>
                <c:pt idx="3">
                  <c:v>57.8801843317972</c:v>
                </c:pt>
                <c:pt idx="4">
                  <c:v>58.171344784248</c:v>
                </c:pt>
              </c:numCache>
            </c:numRef>
          </c:val>
        </c:ser>
        <c:ser>
          <c:idx val="0"/>
          <c:order val="2"/>
          <c:tx>
            <c:strRef>
              <c:f>'merge_220109_48h(1,2)'!$C$12</c:f>
              <c:strCache>
                <c:ptCount val="1"/>
                <c:pt idx="0">
                  <c:v>KPE-MeOH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9_48h(1,2)'!$J$13:$J$17</c:f>
                <c:numCache>
                  <c:formatCode>General</c:formatCode>
                  <c:ptCount val="5"/>
                  <c:pt idx="0">
                    <c:v>3.10155341391835</c:v>
                  </c:pt>
                  <c:pt idx="1">
                    <c:v>6.81630793259425</c:v>
                  </c:pt>
                  <c:pt idx="2">
                    <c:v>3.15783757329225</c:v>
                  </c:pt>
                  <c:pt idx="3">
                    <c:v>5.75579587702328</c:v>
                  </c:pt>
                  <c:pt idx="4">
                    <c:v>0.453235599168587</c:v>
                  </c:pt>
                </c:numCache>
              </c:numRef>
            </c:plus>
            <c:minus>
              <c:numRef>
                <c:f>'merge_220109_48h(1,2)'!$J$13:$J$17</c:f>
                <c:numCache>
                  <c:formatCode>General</c:formatCode>
                  <c:ptCount val="5"/>
                  <c:pt idx="0">
                    <c:v>3.10155341391835</c:v>
                  </c:pt>
                  <c:pt idx="1">
                    <c:v>6.81630793259425</c:v>
                  </c:pt>
                  <c:pt idx="2">
                    <c:v>3.15783757329225</c:v>
                  </c:pt>
                  <c:pt idx="3">
                    <c:v>5.75579587702328</c:v>
                  </c:pt>
                  <c:pt idx="4">
                    <c:v>0.453235599168587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[1]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merge_220109_48h(1,2)'!$C$13:$C$17</c:f>
              <c:numCache>
                <c:formatCode>0.00</c:formatCode>
                <c:ptCount val="5"/>
                <c:pt idx="0">
                  <c:v>78.0037704231252</c:v>
                </c:pt>
                <c:pt idx="1">
                  <c:v>72.3418516966904</c:v>
                </c:pt>
                <c:pt idx="2">
                  <c:v>60.9258483452032</c:v>
                </c:pt>
                <c:pt idx="3">
                  <c:v>41.954335986594</c:v>
                </c:pt>
                <c:pt idx="4">
                  <c:v>22.863426895685</c:v>
                </c:pt>
              </c:numCache>
            </c:numRef>
          </c:val>
        </c:ser>
        <c:ser>
          <c:idx val="1"/>
          <c:order val="3"/>
          <c:tx>
            <c:strRef>
              <c:f>'merge_220109_48h(1,2)'!$D$12</c:f>
              <c:strCache>
                <c:ptCount val="1"/>
                <c:pt idx="0">
                  <c:v>KPE-EtoAc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9_48h(1,2)'!$K$13:$K$17</c:f>
                <c:numCache>
                  <c:formatCode>General</c:formatCode>
                  <c:ptCount val="5"/>
                  <c:pt idx="0">
                    <c:v>1.48708673714139</c:v>
                  </c:pt>
                  <c:pt idx="1">
                    <c:v>3.87768234844235</c:v>
                  </c:pt>
                  <c:pt idx="2">
                    <c:v>2.03511670999228</c:v>
                  </c:pt>
                  <c:pt idx="3">
                    <c:v>2.20100686393635</c:v>
                  </c:pt>
                  <c:pt idx="4">
                    <c:v>0.607276456402358</c:v>
                  </c:pt>
                </c:numCache>
              </c:numRef>
            </c:plus>
            <c:minus>
              <c:numRef>
                <c:f>'merge_220109_48h(1,2)'!$K$13:$K$17</c:f>
                <c:numCache>
                  <c:formatCode>General</c:formatCode>
                  <c:ptCount val="5"/>
                  <c:pt idx="0">
                    <c:v>1.48708673714139</c:v>
                  </c:pt>
                  <c:pt idx="1">
                    <c:v>3.87768234844235</c:v>
                  </c:pt>
                  <c:pt idx="2">
                    <c:v>2.03511670999228</c:v>
                  </c:pt>
                  <c:pt idx="3">
                    <c:v>2.20100686393635</c:v>
                  </c:pt>
                  <c:pt idx="4">
                    <c:v>0.607276456402358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[1]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merge_220109_48h(1,2)'!$D$13:$D$17</c:f>
              <c:numCache>
                <c:formatCode>0.00</c:formatCode>
                <c:ptCount val="5"/>
                <c:pt idx="0">
                  <c:v>80.242982823628</c:v>
                </c:pt>
                <c:pt idx="1">
                  <c:v>71.9208211143695</c:v>
                </c:pt>
                <c:pt idx="2">
                  <c:v>56.0724759111856</c:v>
                </c:pt>
                <c:pt idx="3">
                  <c:v>36.3950565563469</c:v>
                </c:pt>
                <c:pt idx="4">
                  <c:v>21.4893171344784</c:v>
                </c:pt>
              </c:numCache>
            </c:numRef>
          </c:val>
        </c:ser>
        <c:ser>
          <c:idx val="2"/>
          <c:order val="4"/>
          <c:tx>
            <c:strRef>
              <c:f>'merge_220109_48h(1,2)'!$E$12</c:f>
              <c:strCache>
                <c:ptCount val="1"/>
                <c:pt idx="0">
                  <c:v>KPE-DC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9_48h(1,2)'!$L$13:$L$17</c:f>
                <c:numCache>
                  <c:formatCode>General</c:formatCode>
                  <c:ptCount val="5"/>
                  <c:pt idx="0">
                    <c:v>2.99046625725941</c:v>
                  </c:pt>
                  <c:pt idx="1">
                    <c:v>6.02832970135996</c:v>
                  </c:pt>
                  <c:pt idx="2">
                    <c:v>4.82562608526555</c:v>
                  </c:pt>
                  <c:pt idx="3">
                    <c:v>0.55395462120605</c:v>
                  </c:pt>
                  <c:pt idx="4">
                    <c:v>0.364365873841415</c:v>
                  </c:pt>
                </c:numCache>
              </c:numRef>
            </c:plus>
            <c:minus>
              <c:numRef>
                <c:f>'merge_220109_48h(1,2)'!$L$13:$L$17</c:f>
                <c:numCache>
                  <c:formatCode>General</c:formatCode>
                  <c:ptCount val="5"/>
                  <c:pt idx="0">
                    <c:v>2.99046625725941</c:v>
                  </c:pt>
                  <c:pt idx="1">
                    <c:v>6.02832970135996</c:v>
                  </c:pt>
                  <c:pt idx="2">
                    <c:v>4.82562608526555</c:v>
                  </c:pt>
                  <c:pt idx="3">
                    <c:v>0.55395462120605</c:v>
                  </c:pt>
                  <c:pt idx="4">
                    <c:v>0.364365873841415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[1]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merge_220109_48h(1,2)'!$E$13:$E$17</c:f>
              <c:numCache>
                <c:formatCode>0.00</c:formatCode>
                <c:ptCount val="5"/>
                <c:pt idx="0">
                  <c:v>77.5921658986175</c:v>
                </c:pt>
                <c:pt idx="1">
                  <c:v>66.0599078341014</c:v>
                </c:pt>
                <c:pt idx="2">
                  <c:v>57.1658986175115</c:v>
                </c:pt>
                <c:pt idx="3">
                  <c:v>27.6644323418517</c:v>
                </c:pt>
                <c:pt idx="4">
                  <c:v>20.50481776288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8157800"/>
        <c:axId val="588154848"/>
      </c:barChart>
      <c:catAx>
        <c:axId val="58815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oncentration (ug/mL)</a:t>
                </a:r>
                <a:endParaRPr lang="ko-K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588154848"/>
        <c:crosses val="autoZero"/>
        <c:auto val="1"/>
        <c:lblAlgn val="ctr"/>
        <c:lblOffset val="100"/>
        <c:noMultiLvlLbl val="0"/>
      </c:catAx>
      <c:valAx>
        <c:axId val="588154848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ell viability (%) normalized to untreated cells</a:t>
                </a:r>
                <a:endParaRPr lang="ko-K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5881578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96203472222222"/>
          <c:y val="0.0286154578715062"/>
          <c:w val="0.192304166666667"/>
          <c:h val="0.31231264186517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b="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569212962963"/>
          <c:y val="0.0388055555555556"/>
          <c:w val="0.620305787037037"/>
          <c:h val="0.811928333333333"/>
        </c:manualLayout>
      </c:layout>
      <c:barChart>
        <c:barDir val="col"/>
        <c:grouping val="clustered"/>
        <c:varyColors val="0"/>
        <c:ser>
          <c:idx val="3"/>
          <c:order val="0"/>
          <c:tx>
            <c:strRef>
              <c:f>'24, 48h 취합'!$S$31:$T$31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V$40</c:f>
                <c:numCache>
                  <c:formatCode>General</c:formatCode>
                  <c:ptCount val="1"/>
                  <c:pt idx="0">
                    <c:v>0.971885435798409</c:v>
                  </c:pt>
                </c:numCache>
              </c:numRef>
            </c:plus>
            <c:minus>
              <c:numRef>
                <c:f>'24, 48h 취합'!$V$40</c:f>
                <c:numCache>
                  <c:formatCode>General</c:formatCode>
                  <c:ptCount val="1"/>
                  <c:pt idx="0">
                    <c:v>0.971885435798409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24, 48h 취합'!$O$40</c:f>
              <c:numCache>
                <c:formatCode>0.00</c:formatCode>
                <c:ptCount val="1"/>
                <c:pt idx="0">
                  <c:v>91.9963256384582</c:v>
                </c:pt>
              </c:numCache>
            </c:numRef>
          </c:val>
        </c:ser>
        <c:ser>
          <c:idx val="4"/>
          <c:order val="1"/>
          <c:tx>
            <c:strRef>
              <c:f>'24, 48h 취합'!$Q$31:$R$31</c:f>
              <c:strCache>
                <c:ptCount val="1"/>
                <c:pt idx="0">
                  <c:v>KPE-Hexane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U$40:$U$44</c:f>
                <c:numCache>
                  <c:formatCode>General</c:formatCode>
                  <c:ptCount val="5"/>
                  <c:pt idx="0">
                    <c:v>2.12700271267223</c:v>
                  </c:pt>
                  <c:pt idx="1">
                    <c:v>0.567730543385388</c:v>
                  </c:pt>
                  <c:pt idx="2">
                    <c:v>5.05785352455142</c:v>
                  </c:pt>
                  <c:pt idx="3">
                    <c:v>5.08653069300711</c:v>
                  </c:pt>
                  <c:pt idx="4">
                    <c:v>9.38230403591777</c:v>
                  </c:pt>
                </c:numCache>
              </c:numRef>
            </c:plus>
            <c:minus>
              <c:numRef>
                <c:f>'24, 48h 취합'!$U$40:$U$44</c:f>
                <c:numCache>
                  <c:formatCode>General</c:formatCode>
                  <c:ptCount val="5"/>
                  <c:pt idx="0">
                    <c:v>2.12700271267223</c:v>
                  </c:pt>
                  <c:pt idx="1">
                    <c:v>0.567730543385388</c:v>
                  </c:pt>
                  <c:pt idx="2">
                    <c:v>5.05785352455142</c:v>
                  </c:pt>
                  <c:pt idx="3">
                    <c:v>5.08653069300711</c:v>
                  </c:pt>
                  <c:pt idx="4">
                    <c:v>9.38230403591777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'24, 48h 취합'!$N$40:$N$44</c:f>
              <c:numCache>
                <c:formatCode>0.00</c:formatCode>
                <c:ptCount val="5"/>
                <c:pt idx="0">
                  <c:v>95.2359834152499</c:v>
                </c:pt>
                <c:pt idx="1">
                  <c:v>81.783299275178</c:v>
                </c:pt>
                <c:pt idx="2">
                  <c:v>80.1490619547629</c:v>
                </c:pt>
                <c:pt idx="3">
                  <c:v>82.3142580180697</c:v>
                </c:pt>
                <c:pt idx="4">
                  <c:v>87.2755219707859</c:v>
                </c:pt>
              </c:numCache>
            </c:numRef>
          </c:val>
        </c:ser>
        <c:ser>
          <c:idx val="0"/>
          <c:order val="2"/>
          <c:tx>
            <c:strRef>
              <c:f>'24, 48h 취합'!$K$31:$L$31</c:f>
              <c:strCache>
                <c:ptCount val="1"/>
                <c:pt idx="0">
                  <c:v>KPE-MeOH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R$40:$R$44</c:f>
                <c:numCache>
                  <c:formatCode>General</c:formatCode>
                  <c:ptCount val="5"/>
                  <c:pt idx="0">
                    <c:v>8.67433651192388</c:v>
                  </c:pt>
                  <c:pt idx="1">
                    <c:v>9.95447066576355</c:v>
                  </c:pt>
                  <c:pt idx="2">
                    <c:v>4.91729944468739</c:v>
                  </c:pt>
                  <c:pt idx="3">
                    <c:v>3.93132522290282</c:v>
                  </c:pt>
                  <c:pt idx="4">
                    <c:v>2.63379437631173</c:v>
                  </c:pt>
                </c:numCache>
              </c:numRef>
            </c:plus>
            <c:minus>
              <c:numRef>
                <c:f>'24, 48h 취합'!$R$40:$R$44</c:f>
                <c:numCache>
                  <c:formatCode>General</c:formatCode>
                  <c:ptCount val="5"/>
                  <c:pt idx="0">
                    <c:v>8.67433651192388</c:v>
                  </c:pt>
                  <c:pt idx="1">
                    <c:v>9.95447066576355</c:v>
                  </c:pt>
                  <c:pt idx="2">
                    <c:v>4.91729944468739</c:v>
                  </c:pt>
                  <c:pt idx="3">
                    <c:v>3.93132522290282</c:v>
                  </c:pt>
                  <c:pt idx="4">
                    <c:v>2.6337943763117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24, 48h 취합'!$K$40:$K$44</c:f>
              <c:numCache>
                <c:formatCode>0.00</c:formatCode>
                <c:ptCount val="5"/>
                <c:pt idx="0">
                  <c:v>96.2516977595891</c:v>
                </c:pt>
                <c:pt idx="1">
                  <c:v>93.7333270613168</c:v>
                </c:pt>
                <c:pt idx="2">
                  <c:v>74.3330993861825</c:v>
                </c:pt>
                <c:pt idx="3">
                  <c:v>66.7619122515769</c:v>
                </c:pt>
                <c:pt idx="4">
                  <c:v>43.7411811737763</c:v>
                </c:pt>
              </c:numCache>
            </c:numRef>
          </c:val>
        </c:ser>
        <c:ser>
          <c:idx val="1"/>
          <c:order val="3"/>
          <c:tx>
            <c:strRef>
              <c:f>'24, 48h 취합'!$M$31:$N$31</c:f>
              <c:strCache>
                <c:ptCount val="1"/>
                <c:pt idx="0">
                  <c:v>KPE-EtoAc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S$40:$S$44</c:f>
                <c:numCache>
                  <c:formatCode>General</c:formatCode>
                  <c:ptCount val="5"/>
                  <c:pt idx="0">
                    <c:v>5.99854035734499</c:v>
                  </c:pt>
                  <c:pt idx="1">
                    <c:v>4.67121687960446</c:v>
                  </c:pt>
                  <c:pt idx="2">
                    <c:v>2.5839047540629</c:v>
                  </c:pt>
                  <c:pt idx="3">
                    <c:v>1.44407958878768</c:v>
                  </c:pt>
                  <c:pt idx="4">
                    <c:v>2.54203675204418</c:v>
                  </c:pt>
                </c:numCache>
              </c:numRef>
            </c:plus>
            <c:minus>
              <c:numRef>
                <c:f>'24, 48h 취합'!$S$40:$S$44</c:f>
                <c:numCache>
                  <c:formatCode>General</c:formatCode>
                  <c:ptCount val="5"/>
                  <c:pt idx="0">
                    <c:v>5.99854035734499</c:v>
                  </c:pt>
                  <c:pt idx="1">
                    <c:v>4.67121687960446</c:v>
                  </c:pt>
                  <c:pt idx="2">
                    <c:v>2.5839047540629</c:v>
                  </c:pt>
                  <c:pt idx="3">
                    <c:v>1.44407958878768</c:v>
                  </c:pt>
                  <c:pt idx="4">
                    <c:v>2.54203675204418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24, 48h 취합'!$L$40:$L$44</c:f>
              <c:numCache>
                <c:formatCode>0.00</c:formatCode>
                <c:ptCount val="5"/>
                <c:pt idx="0">
                  <c:v>103.735307114202</c:v>
                </c:pt>
                <c:pt idx="1">
                  <c:v>86.8586759354241</c:v>
                </c:pt>
                <c:pt idx="2">
                  <c:v>66.2067054225281</c:v>
                </c:pt>
                <c:pt idx="3">
                  <c:v>42.8486272867334</c:v>
                </c:pt>
                <c:pt idx="4">
                  <c:v>36.994670008275</c:v>
                </c:pt>
              </c:numCache>
            </c:numRef>
          </c:val>
        </c:ser>
        <c:ser>
          <c:idx val="2"/>
          <c:order val="4"/>
          <c:tx>
            <c:strRef>
              <c:f>'24, 48h 취합'!$O$31:$P$31</c:f>
              <c:strCache>
                <c:ptCount val="1"/>
                <c:pt idx="0">
                  <c:v>KPE-DC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T$40:$T$44</c:f>
                <c:numCache>
                  <c:formatCode>General</c:formatCode>
                  <c:ptCount val="5"/>
                  <c:pt idx="0">
                    <c:v>0.527885370367663</c:v>
                  </c:pt>
                  <c:pt idx="1">
                    <c:v>0.688407950070292</c:v>
                  </c:pt>
                  <c:pt idx="2">
                    <c:v>1.64545776507335</c:v>
                  </c:pt>
                  <c:pt idx="3">
                    <c:v>2.42711172404189</c:v>
                  </c:pt>
                  <c:pt idx="4">
                    <c:v>2.1885391263278</c:v>
                  </c:pt>
                </c:numCache>
              </c:numRef>
            </c:plus>
            <c:minus>
              <c:numRef>
                <c:f>'24, 48h 취합'!$T$40:$T$44</c:f>
                <c:numCache>
                  <c:formatCode>General</c:formatCode>
                  <c:ptCount val="5"/>
                  <c:pt idx="0">
                    <c:v>0.527885370367663</c:v>
                  </c:pt>
                  <c:pt idx="1">
                    <c:v>0.688407950070292</c:v>
                  </c:pt>
                  <c:pt idx="2">
                    <c:v>1.64545776507335</c:v>
                  </c:pt>
                  <c:pt idx="3">
                    <c:v>2.42711172404189</c:v>
                  </c:pt>
                  <c:pt idx="4">
                    <c:v>2.1885391263278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24, 48h 취합'!$M$40:$M$44</c:f>
              <c:numCache>
                <c:formatCode>0.00</c:formatCode>
                <c:ptCount val="5"/>
                <c:pt idx="0">
                  <c:v>83.9641658425497</c:v>
                </c:pt>
                <c:pt idx="1">
                  <c:v>81.8665404415554</c:v>
                </c:pt>
                <c:pt idx="2">
                  <c:v>70.8332802944646</c:v>
                </c:pt>
                <c:pt idx="3">
                  <c:v>35.4513986881037</c:v>
                </c:pt>
                <c:pt idx="4">
                  <c:v>32.74983928930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8157800"/>
        <c:axId val="588154848"/>
      </c:barChart>
      <c:catAx>
        <c:axId val="58815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oncentration (µg/mL)</a:t>
                </a:r>
                <a:endParaRPr lang="ko-K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588154848"/>
        <c:crosses val="autoZero"/>
        <c:auto val="1"/>
        <c:lblAlgn val="ctr"/>
        <c:lblOffset val="100"/>
        <c:noMultiLvlLbl val="0"/>
      </c:catAx>
      <c:valAx>
        <c:axId val="588154848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ell viability (%) normalized to untreated cells</a:t>
                </a:r>
                <a:endParaRPr lang="ko-K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5881578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86999537037037"/>
          <c:y val="0.0461041666666667"/>
          <c:w val="0.183602314814815"/>
          <c:h val="0.2798472222222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b="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569212962963"/>
          <c:y val="0.0388055555555556"/>
          <c:w val="0.626185416666667"/>
          <c:h val="0.811928333333333"/>
        </c:manualLayout>
      </c:layout>
      <c:barChart>
        <c:barDir val="col"/>
        <c:grouping val="clustered"/>
        <c:varyColors val="0"/>
        <c:ser>
          <c:idx val="3"/>
          <c:order val="0"/>
          <c:tx>
            <c:strRef>
              <c:f>'merge_220108_24h(1,2)'!$G$16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8_24h(1,2)'!$N$17</c:f>
                <c:numCache>
                  <c:formatCode>General</c:formatCode>
                  <c:ptCount val="1"/>
                  <c:pt idx="0">
                    <c:v>2.09826988281148</c:v>
                  </c:pt>
                </c:numCache>
              </c:numRef>
            </c:plus>
            <c:minus>
              <c:numRef>
                <c:f>'merge_220108_24h(1,2)'!$N$17</c:f>
                <c:numCache>
                  <c:formatCode>General</c:formatCode>
                  <c:ptCount val="1"/>
                  <c:pt idx="0">
                    <c:v>2.098269882811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1]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merge_220108_24h(1,2)'!$G$17</c:f>
              <c:numCache>
                <c:formatCode>0.00</c:formatCode>
                <c:ptCount val="1"/>
                <c:pt idx="0">
                  <c:v>101.12895493768</c:v>
                </c:pt>
              </c:numCache>
            </c:numRef>
          </c:val>
        </c:ser>
        <c:ser>
          <c:idx val="0"/>
          <c:order val="1"/>
          <c:tx>
            <c:strRef>
              <c:f>'merge_220108_24h(1,2)'!$F$16</c:f>
              <c:strCache>
                <c:ptCount val="1"/>
                <c:pt idx="0">
                  <c:v>KPE-Hexane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8_24h(1,2)'!$M$17:$M$21</c:f>
                <c:numCache>
                  <c:formatCode>General</c:formatCode>
                  <c:ptCount val="5"/>
                  <c:pt idx="0">
                    <c:v>2.47114498314952</c:v>
                  </c:pt>
                  <c:pt idx="1">
                    <c:v>1.4592975517776</c:v>
                  </c:pt>
                  <c:pt idx="2">
                    <c:v>2.53894045593828</c:v>
                  </c:pt>
                  <c:pt idx="3">
                    <c:v>2.1084392037298</c:v>
                  </c:pt>
                  <c:pt idx="4">
                    <c:v>7.75241231339229</c:v>
                  </c:pt>
                </c:numCache>
              </c:numRef>
            </c:plus>
            <c:minus>
              <c:numRef>
                <c:f>'merge_220108_24h(1,2)'!$M$17:$M$21</c:f>
                <c:numCache>
                  <c:formatCode>General</c:formatCode>
                  <c:ptCount val="5"/>
                  <c:pt idx="0">
                    <c:v>2.47114498314952</c:v>
                  </c:pt>
                  <c:pt idx="1">
                    <c:v>1.4592975517776</c:v>
                  </c:pt>
                  <c:pt idx="2">
                    <c:v>2.53894045593828</c:v>
                  </c:pt>
                  <c:pt idx="3">
                    <c:v>2.1084392037298</c:v>
                  </c:pt>
                  <c:pt idx="4">
                    <c:v>7.752412313392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1]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merge_220108_24h(1,2)'!$F$17:$F$21</c:f>
              <c:numCache>
                <c:formatCode>0.00</c:formatCode>
                <c:ptCount val="5"/>
                <c:pt idx="0">
                  <c:v>73.8902205177373</c:v>
                </c:pt>
                <c:pt idx="1">
                  <c:v>80.4973633748802</c:v>
                </c:pt>
                <c:pt idx="2">
                  <c:v>75.0551294343241</c:v>
                </c:pt>
                <c:pt idx="3">
                  <c:v>84.3720038350911</c:v>
                </c:pt>
                <c:pt idx="4">
                  <c:v>90.1510067114094</c:v>
                </c:pt>
              </c:numCache>
            </c:numRef>
          </c:val>
        </c:ser>
        <c:ser>
          <c:idx val="1"/>
          <c:order val="2"/>
          <c:tx>
            <c:strRef>
              <c:f>'merge_220108_24h(1,2)'!$C$16</c:f>
              <c:strCache>
                <c:ptCount val="1"/>
                <c:pt idx="0">
                  <c:v>KPE-MeOH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8_24h(1,2)'!$J$17:$J$21</c:f>
                <c:numCache>
                  <c:formatCode>General</c:formatCode>
                  <c:ptCount val="5"/>
                  <c:pt idx="0">
                    <c:v>12.8099545834322</c:v>
                  </c:pt>
                  <c:pt idx="1">
                    <c:v>1.96945848451288</c:v>
                  </c:pt>
                  <c:pt idx="2">
                    <c:v>1.47455153315507</c:v>
                  </c:pt>
                  <c:pt idx="3">
                    <c:v>0.915238882647964</c:v>
                  </c:pt>
                  <c:pt idx="4">
                    <c:v>0.996593449994467</c:v>
                  </c:pt>
                </c:numCache>
              </c:numRef>
            </c:plus>
            <c:minus>
              <c:numRef>
                <c:f>'merge_220108_24h(1,2)'!$J$17:$J$21</c:f>
                <c:numCache>
                  <c:formatCode>General</c:formatCode>
                  <c:ptCount val="5"/>
                  <c:pt idx="0">
                    <c:v>12.8099545834322</c:v>
                  </c:pt>
                  <c:pt idx="1">
                    <c:v>1.96945848451288</c:v>
                  </c:pt>
                  <c:pt idx="2">
                    <c:v>1.47455153315507</c:v>
                  </c:pt>
                  <c:pt idx="3">
                    <c:v>0.915238882647964</c:v>
                  </c:pt>
                  <c:pt idx="4">
                    <c:v>0.9965934499944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1]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merge_220108_24h(1,2)'!$C$17:$C$21</c:f>
              <c:numCache>
                <c:formatCode>0.00</c:formatCode>
                <c:ptCount val="5"/>
                <c:pt idx="0">
                  <c:v>78.3053691275168</c:v>
                </c:pt>
                <c:pt idx="1">
                  <c:v>67.6390220517737</c:v>
                </c:pt>
                <c:pt idx="2">
                  <c:v>63.9621284755513</c:v>
                </c:pt>
                <c:pt idx="3">
                  <c:v>57.6414189837009</c:v>
                </c:pt>
                <c:pt idx="4">
                  <c:v>33.8015340364334</c:v>
                </c:pt>
              </c:numCache>
            </c:numRef>
          </c:val>
        </c:ser>
        <c:ser>
          <c:idx val="2"/>
          <c:order val="3"/>
          <c:tx>
            <c:strRef>
              <c:f>'merge_220108_24h(1,2)'!$D$16</c:f>
              <c:strCache>
                <c:ptCount val="1"/>
                <c:pt idx="0">
                  <c:v>KPE-EtoAc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8_24h(1,2)'!$K$17:$K$21</c:f>
                <c:numCache>
                  <c:formatCode>General</c:formatCode>
                  <c:ptCount val="5"/>
                  <c:pt idx="0">
                    <c:v>8.54222957138112</c:v>
                  </c:pt>
                  <c:pt idx="1">
                    <c:v>0.857612730777544</c:v>
                  </c:pt>
                  <c:pt idx="2">
                    <c:v>2.13894716648472</c:v>
                  </c:pt>
                  <c:pt idx="3">
                    <c:v>1.3118423984621</c:v>
                  </c:pt>
                  <c:pt idx="4">
                    <c:v>1.33218104029872</c:v>
                  </c:pt>
                </c:numCache>
              </c:numRef>
            </c:plus>
            <c:minus>
              <c:numRef>
                <c:f>'merge_220108_24h(1,2)'!$K$17:$K$21</c:f>
                <c:numCache>
                  <c:formatCode>General</c:formatCode>
                  <c:ptCount val="5"/>
                  <c:pt idx="0">
                    <c:v>8.54222957138112</c:v>
                  </c:pt>
                  <c:pt idx="1">
                    <c:v>0.857612730777544</c:v>
                  </c:pt>
                  <c:pt idx="2">
                    <c:v>2.13894716648472</c:v>
                  </c:pt>
                  <c:pt idx="3">
                    <c:v>1.3118423984621</c:v>
                  </c:pt>
                  <c:pt idx="4">
                    <c:v>1.332181040298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[1]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merge_220108_24h(1,2)'!$D$17:$D$21</c:f>
              <c:numCache>
                <c:formatCode>0.00</c:formatCode>
                <c:ptCount val="5"/>
                <c:pt idx="0">
                  <c:v>83.7392138063279</c:v>
                </c:pt>
                <c:pt idx="1">
                  <c:v>69.9688398849473</c:v>
                </c:pt>
                <c:pt idx="2">
                  <c:v>60.7214765100671</c:v>
                </c:pt>
                <c:pt idx="3">
                  <c:v>50.2325023969319</c:v>
                </c:pt>
                <c:pt idx="4">
                  <c:v>27.0062320230106</c:v>
                </c:pt>
              </c:numCache>
            </c:numRef>
          </c:val>
        </c:ser>
        <c:ser>
          <c:idx val="4"/>
          <c:order val="4"/>
          <c:tx>
            <c:strRef>
              <c:f>'merge_220108_24h(1,2)'!$E$16</c:f>
              <c:strCache>
                <c:ptCount val="1"/>
                <c:pt idx="0">
                  <c:v>KPE-DC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merge_220108_24h(1,2)'!$L$17:$L$21</c:f>
                <c:numCache>
                  <c:formatCode>General</c:formatCode>
                  <c:ptCount val="5"/>
                  <c:pt idx="0">
                    <c:v>1.35251968213534</c:v>
                  </c:pt>
                  <c:pt idx="1">
                    <c:v>1.06608380960293</c:v>
                  </c:pt>
                  <c:pt idx="2">
                    <c:v>2.68470072243406</c:v>
                  </c:pt>
                  <c:pt idx="3">
                    <c:v>2.16945512923965</c:v>
                  </c:pt>
                  <c:pt idx="4">
                    <c:v>0.718632011560634</c:v>
                  </c:pt>
                </c:numCache>
              </c:numRef>
            </c:plus>
            <c:minus>
              <c:numRef>
                <c:f>'merge_220108_24h(1,2)'!$L$17:$L$21</c:f>
                <c:numCache>
                  <c:formatCode>General</c:formatCode>
                  <c:ptCount val="5"/>
                  <c:pt idx="0">
                    <c:v>1.35251968213534</c:v>
                  </c:pt>
                  <c:pt idx="1">
                    <c:v>1.06608380960293</c:v>
                  </c:pt>
                  <c:pt idx="2">
                    <c:v>2.68470072243406</c:v>
                  </c:pt>
                  <c:pt idx="3">
                    <c:v>2.16945512923965</c:v>
                  </c:pt>
                  <c:pt idx="4">
                    <c:v>0.7186320115606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erge_220108_24h(1,2)'!$E$17:$E$21</c:f>
              <c:numCache>
                <c:formatCode>0.00</c:formatCode>
                <c:ptCount val="5"/>
                <c:pt idx="0">
                  <c:v>65.4817833173538</c:v>
                </c:pt>
                <c:pt idx="1">
                  <c:v>62.903883029722</c:v>
                </c:pt>
                <c:pt idx="2">
                  <c:v>59.1754554170662</c:v>
                </c:pt>
                <c:pt idx="3">
                  <c:v>41.9798657718121</c:v>
                </c:pt>
                <c:pt idx="4">
                  <c:v>23.8015340364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8157800"/>
        <c:axId val="588154848"/>
      </c:barChart>
      <c:catAx>
        <c:axId val="58815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oncentration (ug/mL)</a:t>
                </a:r>
                <a:endParaRPr lang="ko-K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588154848"/>
        <c:crosses val="autoZero"/>
        <c:auto val="1"/>
        <c:lblAlgn val="ctr"/>
        <c:lblOffset val="100"/>
        <c:noMultiLvlLbl val="0"/>
      </c:catAx>
      <c:valAx>
        <c:axId val="588154848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ell viability (%) normalized to untreated cells</a:t>
                </a:r>
                <a:endParaRPr lang="ko-K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5881578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b="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569212962963"/>
          <c:y val="0.0388055555555556"/>
          <c:w val="0.635004861111111"/>
          <c:h val="0.811928333333333"/>
        </c:manualLayout>
      </c:layout>
      <c:barChart>
        <c:barDir val="col"/>
        <c:grouping val="clustered"/>
        <c:varyColors val="0"/>
        <c:ser>
          <c:idx val="3"/>
          <c:order val="0"/>
          <c:tx>
            <c:strRef>
              <c:f>'24, 48h 취합'!$S$7:$T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V$17</c:f>
                <c:numCache>
                  <c:formatCode>General</c:formatCode>
                  <c:ptCount val="1"/>
                  <c:pt idx="0">
                    <c:v>0.0111628221407419</c:v>
                  </c:pt>
                </c:numCache>
              </c:numRef>
            </c:plus>
            <c:minus>
              <c:numRef>
                <c:f>'24, 48h 취합'!$V$17</c:f>
                <c:numCache>
                  <c:formatCode>General</c:formatCode>
                  <c:ptCount val="1"/>
                  <c:pt idx="0">
                    <c:v>0.0111628221407419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24, 48h 취합'!$O$17</c:f>
              <c:numCache>
                <c:formatCode>0.00</c:formatCode>
                <c:ptCount val="1"/>
                <c:pt idx="0">
                  <c:v>100.648210241082</c:v>
                </c:pt>
              </c:numCache>
            </c:numRef>
          </c:val>
        </c:ser>
        <c:ser>
          <c:idx val="4"/>
          <c:order val="1"/>
          <c:tx>
            <c:strRef>
              <c:f>'24, 48h 취합'!$N$16</c:f>
              <c:strCache>
                <c:ptCount val="1"/>
                <c:pt idx="0">
                  <c:v>KPE-Hexane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U$17:$U$21</c:f>
                <c:numCache>
                  <c:formatCode>General</c:formatCode>
                  <c:ptCount val="5"/>
                  <c:pt idx="0">
                    <c:v>2.12811547401473</c:v>
                  </c:pt>
                  <c:pt idx="1">
                    <c:v>0.94029159482644</c:v>
                  </c:pt>
                  <c:pt idx="2">
                    <c:v>0.968898607292727</c:v>
                  </c:pt>
                  <c:pt idx="3">
                    <c:v>3.28857167699625</c:v>
                  </c:pt>
                  <c:pt idx="4">
                    <c:v>1.98149812000252</c:v>
                  </c:pt>
                </c:numCache>
              </c:numRef>
            </c:plus>
            <c:minus>
              <c:numRef>
                <c:f>'24, 48h 취합'!$U$17:$U$21</c:f>
                <c:numCache>
                  <c:formatCode>General</c:formatCode>
                  <c:ptCount val="5"/>
                  <c:pt idx="0">
                    <c:v>2.12811547401473</c:v>
                  </c:pt>
                  <c:pt idx="1">
                    <c:v>0.94029159482644</c:v>
                  </c:pt>
                  <c:pt idx="2">
                    <c:v>0.968898607292727</c:v>
                  </c:pt>
                  <c:pt idx="3">
                    <c:v>3.28857167699625</c:v>
                  </c:pt>
                  <c:pt idx="4">
                    <c:v>1.9814981200025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'24, 48h 취합'!$N$17:$N$21</c:f>
              <c:numCache>
                <c:formatCode>0.00</c:formatCode>
                <c:ptCount val="5"/>
                <c:pt idx="0">
                  <c:v>72.1930304217957</c:v>
                </c:pt>
                <c:pt idx="1">
                  <c:v>74.5769597609414</c:v>
                </c:pt>
                <c:pt idx="2">
                  <c:v>65.5344790651617</c:v>
                </c:pt>
                <c:pt idx="3">
                  <c:v>60.0848000321732</c:v>
                </c:pt>
                <c:pt idx="4">
                  <c:v>52.8092985772453</c:v>
                </c:pt>
              </c:numCache>
            </c:numRef>
          </c:val>
        </c:ser>
        <c:ser>
          <c:idx val="0"/>
          <c:order val="2"/>
          <c:tx>
            <c:strRef>
              <c:f>'24, 48h 취합'!$K$16</c:f>
              <c:strCache>
                <c:ptCount val="1"/>
                <c:pt idx="0">
                  <c:v>KPE-MeOH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R$17:$R$21</c:f>
                <c:numCache>
                  <c:formatCode>General</c:formatCode>
                  <c:ptCount val="5"/>
                  <c:pt idx="0">
                    <c:v>6.01577069710268</c:v>
                  </c:pt>
                  <c:pt idx="1">
                    <c:v>6.11883514784601</c:v>
                  </c:pt>
                  <c:pt idx="2">
                    <c:v>4.40159319148648</c:v>
                  </c:pt>
                  <c:pt idx="3">
                    <c:v>2.54061708799254</c:v>
                  </c:pt>
                  <c:pt idx="4">
                    <c:v>0.562878193476737</c:v>
                  </c:pt>
                </c:numCache>
              </c:numRef>
            </c:plus>
            <c:minus>
              <c:numRef>
                <c:f>'24, 48h 취합'!$R$17:$R$21</c:f>
                <c:numCache>
                  <c:formatCode>General</c:formatCode>
                  <c:ptCount val="5"/>
                  <c:pt idx="0">
                    <c:v>6.01577069710268</c:v>
                  </c:pt>
                  <c:pt idx="1">
                    <c:v>6.11883514784601</c:v>
                  </c:pt>
                  <c:pt idx="2">
                    <c:v>4.40159319148648</c:v>
                  </c:pt>
                  <c:pt idx="3">
                    <c:v>2.54061708799254</c:v>
                  </c:pt>
                  <c:pt idx="4">
                    <c:v>0.562878193476737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24, 48h 취합'!$K$17:$K$21</c:f>
              <c:numCache>
                <c:formatCode>0.00</c:formatCode>
                <c:ptCount val="5"/>
                <c:pt idx="0">
                  <c:v>109.752564849387</c:v>
                </c:pt>
                <c:pt idx="1">
                  <c:v>78.6404390739402</c:v>
                </c:pt>
                <c:pt idx="2">
                  <c:v>67.5712225486008</c:v>
                </c:pt>
                <c:pt idx="3">
                  <c:v>54.9475699190082</c:v>
                </c:pt>
                <c:pt idx="4">
                  <c:v>25.4772383752261</c:v>
                </c:pt>
              </c:numCache>
            </c:numRef>
          </c:val>
        </c:ser>
        <c:ser>
          <c:idx val="1"/>
          <c:order val="3"/>
          <c:tx>
            <c:strRef>
              <c:f>'24, 48h 취합'!$L$16</c:f>
              <c:strCache>
                <c:ptCount val="1"/>
                <c:pt idx="0">
                  <c:v>KPE-EtoAc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S$17:$S$21</c:f>
                <c:numCache>
                  <c:formatCode>General</c:formatCode>
                  <c:ptCount val="5"/>
                  <c:pt idx="0">
                    <c:v>12.7442112097712</c:v>
                  </c:pt>
                  <c:pt idx="1">
                    <c:v>6.83438795221185</c:v>
                  </c:pt>
                  <c:pt idx="2">
                    <c:v>0.154214167616141</c:v>
                  </c:pt>
                  <c:pt idx="3">
                    <c:v>0.922042043106215</c:v>
                  </c:pt>
                  <c:pt idx="4">
                    <c:v>0.506636650242785</c:v>
                  </c:pt>
                </c:numCache>
              </c:numRef>
            </c:plus>
            <c:minus>
              <c:numRef>
                <c:f>'24, 48h 취합'!$S$17:$S$21</c:f>
                <c:numCache>
                  <c:formatCode>General</c:formatCode>
                  <c:ptCount val="5"/>
                  <c:pt idx="0">
                    <c:v>12.7442112097712</c:v>
                  </c:pt>
                  <c:pt idx="1">
                    <c:v>6.83438795221185</c:v>
                  </c:pt>
                  <c:pt idx="2">
                    <c:v>0.154214167616141</c:v>
                  </c:pt>
                  <c:pt idx="3">
                    <c:v>0.922042043106215</c:v>
                  </c:pt>
                  <c:pt idx="4">
                    <c:v>0.506636650242785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24, 48h 취합'!$L$17:$L$21</c:f>
              <c:numCache>
                <c:formatCode>0.00</c:formatCode>
                <c:ptCount val="5"/>
                <c:pt idx="0">
                  <c:v>112.374606763598</c:v>
                </c:pt>
                <c:pt idx="1">
                  <c:v>80.1037869000111</c:v>
                </c:pt>
                <c:pt idx="2">
                  <c:v>57.5471177426365</c:v>
                </c:pt>
                <c:pt idx="3">
                  <c:v>25.338436097756</c:v>
                </c:pt>
                <c:pt idx="4">
                  <c:v>23.9645840819952</c:v>
                </c:pt>
              </c:numCache>
            </c:numRef>
          </c:val>
        </c:ser>
        <c:ser>
          <c:idx val="2"/>
          <c:order val="4"/>
          <c:tx>
            <c:strRef>
              <c:f>'24, 48h 취합'!$M$16</c:f>
              <c:strCache>
                <c:ptCount val="1"/>
                <c:pt idx="0">
                  <c:v>KPE-DC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24, 48h 취합'!$T$17:$T$21</c:f>
                <c:numCache>
                  <c:formatCode>General</c:formatCode>
                  <c:ptCount val="5"/>
                  <c:pt idx="0">
                    <c:v>1.62787853552118</c:v>
                  </c:pt>
                  <c:pt idx="1">
                    <c:v>6.78304261953315</c:v>
                  </c:pt>
                  <c:pt idx="2">
                    <c:v>4.56585536742</c:v>
                  </c:pt>
                  <c:pt idx="3">
                    <c:v>0.967353525927527</c:v>
                  </c:pt>
                  <c:pt idx="4">
                    <c:v>0.316560893350965</c:v>
                  </c:pt>
                </c:numCache>
              </c:numRef>
            </c:plus>
            <c:minus>
              <c:numRef>
                <c:f>'24, 48h 취합'!$T$17:$T$21</c:f>
                <c:numCache>
                  <c:formatCode>General</c:formatCode>
                  <c:ptCount val="5"/>
                  <c:pt idx="0">
                    <c:v>1.62787853552118</c:v>
                  </c:pt>
                  <c:pt idx="1">
                    <c:v>6.78304261953315</c:v>
                  </c:pt>
                  <c:pt idx="2">
                    <c:v>4.56585536742</c:v>
                  </c:pt>
                  <c:pt idx="3">
                    <c:v>0.967353525927527</c:v>
                  </c:pt>
                  <c:pt idx="4">
                    <c:v>0.316560893350965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'211230_48h'!$B$31:$B$35</c:f>
              <c:numCache>
                <c:formatCode>General</c:formatCode>
                <c:ptCount val="5"/>
                <c:pt idx="0">
                  <c:v>3.12</c:v>
                </c:pt>
                <c:pt idx="1">
                  <c:v>6.25</c:v>
                </c:pt>
                <c:pt idx="2">
                  <c:v>12.5</c:v>
                </c:pt>
                <c:pt idx="3">
                  <c:v>25</c:v>
                </c:pt>
                <c:pt idx="4">
                  <c:v>50</c:v>
                </c:pt>
              </c:numCache>
            </c:numRef>
          </c:cat>
          <c:val>
            <c:numRef>
              <c:f>'24, 48h 취합'!$M$17:$M$21</c:f>
              <c:numCache>
                <c:formatCode>0.00</c:formatCode>
                <c:ptCount val="5"/>
                <c:pt idx="0">
                  <c:v>73.2823046610781</c:v>
                </c:pt>
                <c:pt idx="1">
                  <c:v>71.5649138756612</c:v>
                </c:pt>
                <c:pt idx="2">
                  <c:v>64.5206695863505</c:v>
                </c:pt>
                <c:pt idx="3">
                  <c:v>23.2793787885685</c:v>
                </c:pt>
                <c:pt idx="4">
                  <c:v>22.41842499669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8157800"/>
        <c:axId val="588154848"/>
      </c:barChart>
      <c:catAx>
        <c:axId val="58815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oncentration (µg/mL)</a:t>
                </a:r>
                <a:endParaRPr lang="ko-K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588154848"/>
        <c:crosses val="autoZero"/>
        <c:auto val="1"/>
        <c:lblAlgn val="ctr"/>
        <c:lblOffset val="100"/>
        <c:noMultiLvlLbl val="0"/>
      </c:catAx>
      <c:valAx>
        <c:axId val="588154848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ell viability (%) normalized to untreated cells</a:t>
                </a:r>
                <a:endParaRPr lang="ko-K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58815780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b="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3BB2A0-7B93-42E6-B8C5-3E7628980280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D00DE0-6CEC-4885-856D-900DFEB4D676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 hasCustomPrompt="1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</p:txBody>
      </p:sp>
      <p:sp>
        <p:nvSpPr>
          <p:cNvPr id="6" name="내용 개체 틀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  <a:endParaRPr lang="ko-KR" altLang="en-US"/>
          </a:p>
          <a:p>
            <a:pPr lvl="1"/>
            <a:r>
              <a:rPr lang="ko-KR" altLang="en-US"/>
              <a:t>두 번째 수준</a:t>
            </a:r>
            <a:endParaRPr lang="ko-KR" altLang="en-US"/>
          </a:p>
          <a:p>
            <a:pPr lvl="2"/>
            <a:r>
              <a:rPr lang="ko-KR" altLang="en-US"/>
              <a:t>세 번째 수준</a:t>
            </a:r>
            <a:endParaRPr lang="ko-KR" altLang="en-US"/>
          </a:p>
          <a:p>
            <a:pPr lvl="3"/>
            <a:r>
              <a:rPr lang="ko-KR" altLang="en-US"/>
              <a:t>네 번째 수준</a:t>
            </a:r>
            <a:endParaRPr lang="ko-KR" altLang="en-US"/>
          </a:p>
          <a:p>
            <a:pPr lvl="4"/>
            <a:r>
              <a:rPr lang="ko-KR" altLang="en-US"/>
              <a:t>다섯 번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17A657-4DA0-459F-A01A-A020E4811390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F9FC75-6E6C-4B3C-8696-C3B693F43607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1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2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3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4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5.xml"/><Relationship Id="rId1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.xml"/><Relationship Id="rId1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7.xml"/><Relationship Id="rId4" Type="http://schemas.openxmlformats.org/officeDocument/2006/relationships/chart" Target="../charts/chart4.xml"/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1"/>
          <a:srcRect/>
          <a:stretch>
            <a:fillRect/>
          </a:stretch>
        </p:blipFill>
        <p:spPr bwMode="auto">
          <a:xfrm>
            <a:off x="0" y="883454"/>
            <a:ext cx="12192000" cy="50910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0"/>
          <p:cNvSpPr txBox="1"/>
          <p:nvPr/>
        </p:nvSpPr>
        <p:spPr>
          <a:xfrm>
            <a:off x="706201" y="1108925"/>
            <a:ext cx="878767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F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 Box 1"/>
          <p:cNvSpPr txBox="1"/>
          <p:nvPr/>
        </p:nvSpPr>
        <p:spPr>
          <a:xfrm>
            <a:off x="192405" y="105410"/>
            <a:ext cx="158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IN" altLang="en-US">
                <a:latin typeface="Arial Black" panose="020B0A04020102020204" charset="0"/>
                <a:cs typeface="Arial Black" panose="020B0A04020102020204" charset="0"/>
              </a:rPr>
              <a:t>Figure S1</a:t>
            </a:r>
            <a:endParaRPr lang="en-IN" altLang="en-US">
              <a:latin typeface="Arial Black" panose="020B0A04020102020204" charset="0"/>
              <a:cs typeface="Arial Black" panose="020B0A040201020202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1"/>
          <a:srcRect/>
          <a:stretch>
            <a:fillRect/>
          </a:stretch>
        </p:blipFill>
        <p:spPr bwMode="auto">
          <a:xfrm>
            <a:off x="0" y="883800"/>
            <a:ext cx="12216961" cy="509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Box 1"/>
          <p:cNvSpPr txBox="1"/>
          <p:nvPr/>
        </p:nvSpPr>
        <p:spPr>
          <a:xfrm>
            <a:off x="706201" y="1108925"/>
            <a:ext cx="84350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F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 Box 2"/>
          <p:cNvSpPr txBox="1"/>
          <p:nvPr>
            <p:custDataLst>
              <p:tags r:id="rId2"/>
            </p:custDataLst>
          </p:nvPr>
        </p:nvSpPr>
        <p:spPr>
          <a:xfrm>
            <a:off x="192405" y="105410"/>
            <a:ext cx="158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IN" altLang="en-US">
                <a:latin typeface="Arial Black" panose="020B0A04020102020204" charset="0"/>
                <a:cs typeface="Arial Black" panose="020B0A04020102020204" charset="0"/>
              </a:rPr>
              <a:t>Figure S2</a:t>
            </a:r>
            <a:endParaRPr lang="en-IN" altLang="en-US">
              <a:latin typeface="Arial Black" panose="020B0A04020102020204" charset="0"/>
              <a:cs typeface="Arial Black" panose="020B0A040201020202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1"/>
          <a:srcRect/>
          <a:stretch>
            <a:fillRect/>
          </a:stretch>
        </p:blipFill>
        <p:spPr bwMode="auto">
          <a:xfrm>
            <a:off x="-12480" y="883800"/>
            <a:ext cx="12216961" cy="509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Box 1"/>
          <p:cNvSpPr txBox="1"/>
          <p:nvPr/>
        </p:nvSpPr>
        <p:spPr>
          <a:xfrm>
            <a:off x="706201" y="1108925"/>
            <a:ext cx="84350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F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 Box 2"/>
          <p:cNvSpPr txBox="1"/>
          <p:nvPr>
            <p:custDataLst>
              <p:tags r:id="rId2"/>
            </p:custDataLst>
          </p:nvPr>
        </p:nvSpPr>
        <p:spPr>
          <a:xfrm>
            <a:off x="192405" y="105410"/>
            <a:ext cx="158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IN" altLang="en-US">
                <a:latin typeface="Arial Black" panose="020B0A04020102020204" charset="0"/>
                <a:cs typeface="Arial Black" panose="020B0A04020102020204" charset="0"/>
              </a:rPr>
              <a:t>Figure S3</a:t>
            </a:r>
            <a:endParaRPr lang="en-IN" altLang="en-US">
              <a:latin typeface="Arial Black" panose="020B0A04020102020204" charset="0"/>
              <a:cs typeface="Arial Black" panose="020B0A040201020202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1"/>
          <a:srcRect/>
          <a:stretch>
            <a:fillRect/>
          </a:stretch>
        </p:blipFill>
        <p:spPr bwMode="auto">
          <a:xfrm>
            <a:off x="-25977" y="883800"/>
            <a:ext cx="12243955" cy="509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Box 1"/>
          <p:cNvSpPr txBox="1"/>
          <p:nvPr/>
        </p:nvSpPr>
        <p:spPr>
          <a:xfrm>
            <a:off x="706201" y="1108925"/>
            <a:ext cx="1875835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PE-Hexane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 Box 2"/>
          <p:cNvSpPr txBox="1"/>
          <p:nvPr>
            <p:custDataLst>
              <p:tags r:id="rId2"/>
            </p:custDataLst>
          </p:nvPr>
        </p:nvSpPr>
        <p:spPr>
          <a:xfrm>
            <a:off x="192405" y="105410"/>
            <a:ext cx="158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IN" altLang="en-US">
                <a:latin typeface="Arial Black" panose="020B0A04020102020204" charset="0"/>
                <a:cs typeface="Arial Black" panose="020B0A04020102020204" charset="0"/>
              </a:rPr>
              <a:t>Figure S4</a:t>
            </a:r>
            <a:endParaRPr lang="en-IN" altLang="en-US">
              <a:latin typeface="Arial Black" panose="020B0A04020102020204" charset="0"/>
              <a:cs typeface="Arial Black" panose="020B0A0402010202020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1"/>
          <a:srcRect/>
          <a:stretch>
            <a:fillRect/>
          </a:stretch>
        </p:blipFill>
        <p:spPr bwMode="auto">
          <a:xfrm>
            <a:off x="-32368" y="883800"/>
            <a:ext cx="12256736" cy="509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706201" y="1108925"/>
            <a:ext cx="1625766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PE-DCM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 Box 1"/>
          <p:cNvSpPr txBox="1"/>
          <p:nvPr>
            <p:custDataLst>
              <p:tags r:id="rId2"/>
            </p:custDataLst>
          </p:nvPr>
        </p:nvSpPr>
        <p:spPr>
          <a:xfrm>
            <a:off x="192405" y="105410"/>
            <a:ext cx="158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IN" altLang="en-US">
                <a:latin typeface="Arial Black" panose="020B0A04020102020204" charset="0"/>
                <a:cs typeface="Arial Black" panose="020B0A04020102020204" charset="0"/>
              </a:rPr>
              <a:t>Figure S5</a:t>
            </a:r>
            <a:endParaRPr lang="en-IN" altLang="en-US">
              <a:latin typeface="Arial Black" panose="020B0A04020102020204" charset="0"/>
              <a:cs typeface="Arial Black" panose="020B0A0402010202020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1"/>
          <a:srcRect/>
          <a:stretch>
            <a:fillRect/>
          </a:stretch>
        </p:blipFill>
        <p:spPr bwMode="auto">
          <a:xfrm>
            <a:off x="-25978" y="883800"/>
            <a:ext cx="12243956" cy="509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706201" y="1108925"/>
            <a:ext cx="1715534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PE-</a:t>
            </a:r>
            <a:r>
              <a:rPr lang="en-US" altLang="ko-KR" sz="2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toAc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 Box 1"/>
          <p:cNvSpPr txBox="1"/>
          <p:nvPr>
            <p:custDataLst>
              <p:tags r:id="rId2"/>
            </p:custDataLst>
          </p:nvPr>
        </p:nvSpPr>
        <p:spPr>
          <a:xfrm>
            <a:off x="192405" y="105410"/>
            <a:ext cx="158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IN" altLang="en-US">
                <a:latin typeface="Arial Black" panose="020B0A04020102020204" charset="0"/>
                <a:cs typeface="Arial Black" panose="020B0A04020102020204" charset="0"/>
              </a:rPr>
              <a:t>Figure S6</a:t>
            </a:r>
            <a:endParaRPr lang="en-IN" altLang="en-US">
              <a:latin typeface="Arial Black" panose="020B0A04020102020204" charset="0"/>
              <a:cs typeface="Arial Black" panose="020B0A0402010202020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1"/>
          <a:srcRect/>
          <a:stretch>
            <a:fillRect/>
          </a:stretch>
        </p:blipFill>
        <p:spPr bwMode="auto">
          <a:xfrm>
            <a:off x="-25978" y="883800"/>
            <a:ext cx="12243956" cy="509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706201" y="1108925"/>
            <a:ext cx="1786066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PE-MeOH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 Box 1"/>
          <p:cNvSpPr txBox="1"/>
          <p:nvPr>
            <p:custDataLst>
              <p:tags r:id="rId2"/>
            </p:custDataLst>
          </p:nvPr>
        </p:nvSpPr>
        <p:spPr>
          <a:xfrm>
            <a:off x="192405" y="105410"/>
            <a:ext cx="158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IN" altLang="en-US">
                <a:latin typeface="Arial Black" panose="020B0A04020102020204" charset="0"/>
                <a:cs typeface="Arial Black" panose="020B0A04020102020204" charset="0"/>
              </a:rPr>
              <a:t>Figure S7</a:t>
            </a:r>
            <a:endParaRPr lang="en-IN" altLang="en-US">
              <a:latin typeface="Arial Black" panose="020B0A04020102020204" charset="0"/>
              <a:cs typeface="Arial Black" panose="020B0A0402010202020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차트 5"/>
          <p:cNvGraphicFramePr/>
          <p:nvPr/>
        </p:nvGraphicFramePr>
        <p:xfrm>
          <a:off x="4193875" y="3317624"/>
          <a:ext cx="432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9" name="차트 8"/>
          <p:cNvGraphicFramePr/>
          <p:nvPr/>
        </p:nvGraphicFramePr>
        <p:xfrm>
          <a:off x="4193875" y="-20957"/>
          <a:ext cx="432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차트 6"/>
          <p:cNvGraphicFramePr/>
          <p:nvPr/>
        </p:nvGraphicFramePr>
        <p:xfrm>
          <a:off x="629355" y="3317624"/>
          <a:ext cx="432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차트 7"/>
          <p:cNvGraphicFramePr/>
          <p:nvPr/>
        </p:nvGraphicFramePr>
        <p:xfrm>
          <a:off x="629355" y="-20957"/>
          <a:ext cx="432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60354" y="114273"/>
            <a:ext cx="3690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80312" y="3196771"/>
            <a:ext cx="3690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7790915" y="2364310"/>
          <a:ext cx="3956230" cy="720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91246"/>
                <a:gridCol w="791246"/>
                <a:gridCol w="791246"/>
                <a:gridCol w="791246"/>
                <a:gridCol w="791246"/>
              </a:tblGrid>
              <a:tr h="24000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</a:t>
                      </a:r>
                      <a:r>
                        <a:rPr lang="en-US" altLang="ko-KR" sz="1100" b="0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altLang="ko-KR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+mn-cs"/>
                        </a:rPr>
                        <a:t>µg/mL</a:t>
                      </a:r>
                      <a:r>
                        <a:rPr lang="en-US" altLang="ko-KR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KPE-Hexane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KPE-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OH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KPE-</a:t>
                      </a:r>
                      <a:r>
                        <a:rPr lang="en-US" sz="11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oA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KPE-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000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h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indent="0" algn="ctr" fontAlgn="b">
                        <a:buFont typeface="Wingdings" panose="05000000000000000000" pitchFamily="2" charset="2"/>
                        <a:buNone/>
                      </a:pP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&gt; 5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43.2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21.1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19.8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000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 h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gt; 5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.2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15.4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16.9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표 4"/>
          <p:cNvGraphicFramePr>
            <a:graphicFrameLocks noGrp="1"/>
          </p:cNvGraphicFramePr>
          <p:nvPr/>
        </p:nvGraphicFramePr>
        <p:xfrm>
          <a:off x="7790915" y="5672890"/>
          <a:ext cx="3956230" cy="720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91246"/>
                <a:gridCol w="791246"/>
                <a:gridCol w="791246"/>
                <a:gridCol w="791246"/>
                <a:gridCol w="791246"/>
              </a:tblGrid>
              <a:tr h="24000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</a:t>
                      </a:r>
                      <a:r>
                        <a:rPr lang="en-US" altLang="ko-KR" sz="1100" b="0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altLang="ko-KR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µg/mL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KPE-Hexane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KPE-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OH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KPE-</a:t>
                      </a:r>
                      <a:r>
                        <a:rPr lang="en-US" sz="11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oA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KPE-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000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h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gt; 5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33.0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25.25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19.1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000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 h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&gt; 5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.7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16.3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50" charset="-127"/>
                          <a:cs typeface="Times New Roman" panose="02020603050405020304" pitchFamily="18" charset="0"/>
                        </a:rPr>
                        <a:t>15.54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7732584" y="1901369"/>
            <a:ext cx="1562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7732584" y="5186901"/>
            <a:ext cx="1562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 Box 11"/>
          <p:cNvSpPr txBox="1"/>
          <p:nvPr>
            <p:custDataLst>
              <p:tags r:id="rId5"/>
            </p:custDataLst>
          </p:nvPr>
        </p:nvSpPr>
        <p:spPr>
          <a:xfrm>
            <a:off x="0" y="6489700"/>
            <a:ext cx="158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IN" altLang="en-US">
                <a:latin typeface="Arial Black" panose="020B0A04020102020204" charset="0"/>
                <a:cs typeface="Arial Black" panose="020B0A04020102020204" charset="0"/>
              </a:rPr>
              <a:t>Figure S8</a:t>
            </a:r>
            <a:endParaRPr lang="en-IN" altLang="en-US">
              <a:latin typeface="Arial Black" panose="020B0A04020102020204" charset="0"/>
              <a:cs typeface="Arial Black" panose="020B0A040201020202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7</Words>
  <Application>WPS Presentation</Application>
  <PresentationFormat>와이드스크린</PresentationFormat>
  <Paragraphs>98</Paragraphs>
  <Slides>8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20" baseType="lpstr">
      <vt:lpstr>Arial</vt:lpstr>
      <vt:lpstr>SimSun</vt:lpstr>
      <vt:lpstr>Wingdings</vt:lpstr>
      <vt:lpstr>Times New Roman</vt:lpstr>
      <vt:lpstr>Malgun Gothic</vt:lpstr>
      <vt:lpstr>times</vt:lpstr>
      <vt:lpstr>Microsoft YaHei</vt:lpstr>
      <vt:lpstr>Arial Unicode MS</vt:lpstr>
      <vt:lpstr>Calibri</vt:lpstr>
      <vt:lpstr>Bahnschrift</vt:lpstr>
      <vt:lpstr>Arial Black</vt:lpstr>
      <vt:lpstr>Office 테마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박견석</dc:creator>
  <cp:lastModifiedBy>Judy G</cp:lastModifiedBy>
  <cp:revision>3</cp:revision>
  <dcterms:created xsi:type="dcterms:W3CDTF">2024-08-05T11:38:00Z</dcterms:created>
  <dcterms:modified xsi:type="dcterms:W3CDTF">2024-08-07T04:58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C2A65178A0B469C9C6DB7BF9CFE0A88_13</vt:lpwstr>
  </property>
  <property fmtid="{D5CDD505-2E9C-101B-9397-08002B2CF9AE}" pid="3" name="KSOProductBuildVer">
    <vt:lpwstr>1033-12.2.0.17153</vt:lpwstr>
  </property>
</Properties>
</file>